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Alcím mintájának szerkesztése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87F6A-60DC-4C92-A6EC-A35105425D15}" type="datetimeFigureOut">
              <a:rPr lang="hu-HU" smtClean="0"/>
              <a:pPr/>
              <a:t>2020.07.09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37F5A-FB6A-4AF7-8E00-D3DE1FF86ABA}" type="slidenum">
              <a:rPr lang="hu-HU" smtClean="0"/>
              <a:pPr/>
              <a:t>‹#›</a:t>
            </a:fld>
            <a:endParaRPr lang="hu-H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nucleotide/LC496579.1?report=genbank&amp;log$=nuclalign&amp;blast_rank=1&amp;RID=6U6C5G3K01R&amp;from=17&amp;to=559" TargetMode="External"/><Relationship Id="rId2" Type="http://schemas.openxmlformats.org/officeDocument/2006/relationships/hyperlink" Target="https://www.ncbi.nlm.nih.gov/nucleotide/LC496579.1?report=genbank&amp;log$=nuclalign&amp;blast_rank=1&amp;RID=6U6C5G3K01R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áblázat 4"/>
          <p:cNvGraphicFramePr>
            <a:graphicFrameLocks noGrp="1"/>
          </p:cNvGraphicFramePr>
          <p:nvPr/>
        </p:nvGraphicFramePr>
        <p:xfrm>
          <a:off x="1259632" y="332656"/>
          <a:ext cx="5968365" cy="567690"/>
        </p:xfrm>
        <a:graphic>
          <a:graphicData uri="http://schemas.openxmlformats.org/drawingml/2006/table">
            <a:tbl>
              <a:tblPr/>
              <a:tblGrid>
                <a:gridCol w="1671955"/>
                <a:gridCol w="744220"/>
                <a:gridCol w="1301750"/>
                <a:gridCol w="989965"/>
                <a:gridCol w="1260475"/>
              </a:tblGrid>
              <a:tr h="0">
                <a:tc gridSpan="5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hu-HU" sz="1000" b="1" dirty="0" err="1">
                          <a:latin typeface="Courier New"/>
                          <a:ea typeface="Times New Roman"/>
                          <a:cs typeface="Times New Roman"/>
                        </a:rPr>
                        <a:t>Alignment</a:t>
                      </a:r>
                      <a:r>
                        <a:rPr lang="hu-HU" sz="1000" b="1" dirty="0">
                          <a:latin typeface="Courier New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hu-HU" sz="1000" b="1" dirty="0" err="1">
                          <a:latin typeface="Courier New"/>
                          <a:ea typeface="Times New Roman"/>
                          <a:cs typeface="Times New Roman"/>
                        </a:rPr>
                        <a:t>statistics</a:t>
                      </a:r>
                      <a:r>
                        <a:rPr lang="hu-HU" sz="1000" b="1" dirty="0">
                          <a:latin typeface="Courier New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hu-HU" sz="1000" b="1" dirty="0" err="1">
                          <a:latin typeface="Courier New"/>
                          <a:ea typeface="Times New Roman"/>
                          <a:cs typeface="Times New Roman"/>
                        </a:rPr>
                        <a:t>for</a:t>
                      </a:r>
                      <a:r>
                        <a:rPr lang="hu-HU" sz="1000" b="1" dirty="0">
                          <a:latin typeface="Courier New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hu-HU" sz="1000" b="1" dirty="0" err="1">
                          <a:latin typeface="Courier New"/>
                          <a:ea typeface="Times New Roman"/>
                          <a:cs typeface="Times New Roman"/>
                        </a:rPr>
                        <a:t>match</a:t>
                      </a:r>
                      <a:r>
                        <a:rPr lang="hu-HU" sz="1000" b="1" dirty="0">
                          <a:latin typeface="Courier New"/>
                          <a:ea typeface="Times New Roman"/>
                          <a:cs typeface="Times New Roman"/>
                        </a:rPr>
                        <a:t> #1</a:t>
                      </a:r>
                      <a:endParaRPr lang="hu-HU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7305" marR="27305" marT="6985" marB="698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hu-H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hu-H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hu-H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hu-HU"/>
                    </a:p>
                  </a:txBody>
                  <a:tcPr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hu-HU" sz="1000">
                          <a:solidFill>
                            <a:srgbClr val="606060"/>
                          </a:solidFill>
                          <a:latin typeface="Courier New"/>
                          <a:ea typeface="Times New Roman"/>
                          <a:cs typeface="Times New Roman"/>
                        </a:rPr>
                        <a:t>Score</a:t>
                      </a:r>
                      <a:endParaRPr lang="hu-HU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7305" marR="27305" marT="6985" marB="698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hu-HU" sz="1000">
                          <a:solidFill>
                            <a:srgbClr val="606060"/>
                          </a:solidFill>
                          <a:latin typeface="Courier New"/>
                          <a:ea typeface="Times New Roman"/>
                          <a:cs typeface="Times New Roman"/>
                        </a:rPr>
                        <a:t>Expect</a:t>
                      </a:r>
                      <a:endParaRPr lang="hu-HU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7305" marR="27305" marT="6985" marB="698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hu-HU" sz="1000">
                          <a:solidFill>
                            <a:srgbClr val="606060"/>
                          </a:solidFill>
                          <a:latin typeface="Courier New"/>
                          <a:ea typeface="Times New Roman"/>
                          <a:cs typeface="Times New Roman"/>
                        </a:rPr>
                        <a:t>Identities</a:t>
                      </a:r>
                      <a:endParaRPr lang="hu-HU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7305" marR="27305" marT="6985" marB="698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hu-HU" sz="1000">
                          <a:solidFill>
                            <a:srgbClr val="606060"/>
                          </a:solidFill>
                          <a:latin typeface="Courier New"/>
                          <a:ea typeface="Times New Roman"/>
                          <a:cs typeface="Times New Roman"/>
                        </a:rPr>
                        <a:t>Gaps</a:t>
                      </a:r>
                      <a:endParaRPr lang="hu-HU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7305" marR="27305" marT="6985" marB="698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hu-HU" sz="1000">
                          <a:solidFill>
                            <a:srgbClr val="606060"/>
                          </a:solidFill>
                          <a:latin typeface="Courier New"/>
                          <a:ea typeface="Times New Roman"/>
                          <a:cs typeface="Times New Roman"/>
                        </a:rPr>
                        <a:t>Strand</a:t>
                      </a:r>
                      <a:endParaRPr lang="hu-HU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7305" marR="27305" marT="6985" marB="698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hu-HU" sz="1000">
                          <a:latin typeface="Courier New"/>
                          <a:ea typeface="Times New Roman"/>
                          <a:cs typeface="Times New Roman"/>
                        </a:rPr>
                        <a:t>1003 bits(543)</a:t>
                      </a:r>
                      <a:endParaRPr lang="hu-HU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7305" marR="27305" marT="6985" marB="698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hu-HU" sz="1000">
                          <a:latin typeface="Courier New"/>
                          <a:ea typeface="Times New Roman"/>
                          <a:cs typeface="Times New Roman"/>
                        </a:rPr>
                        <a:t>0.0</a:t>
                      </a:r>
                      <a:endParaRPr lang="hu-HU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7305" marR="27305" marT="6985" marB="698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hu-HU" sz="1000">
                          <a:latin typeface="Courier New"/>
                          <a:ea typeface="Times New Roman"/>
                          <a:cs typeface="Times New Roman"/>
                        </a:rPr>
                        <a:t>543/543(100%)</a:t>
                      </a:r>
                      <a:endParaRPr lang="hu-HU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7305" marR="27305" marT="6985" marB="698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hu-HU" sz="1000">
                          <a:latin typeface="Courier New"/>
                          <a:ea typeface="Times New Roman"/>
                          <a:cs typeface="Times New Roman"/>
                        </a:rPr>
                        <a:t>0/543(0%)</a:t>
                      </a:r>
                      <a:endParaRPr lang="hu-HU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7305" marR="27305" marT="6985" marB="698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hu-HU" sz="1000" dirty="0">
                          <a:latin typeface="Courier New"/>
                          <a:ea typeface="Times New Roman"/>
                          <a:cs typeface="Times New Roman"/>
                        </a:rPr>
                        <a:t>Plus/</a:t>
                      </a:r>
                      <a:r>
                        <a:rPr lang="hu-HU" sz="1000" dirty="0" err="1">
                          <a:latin typeface="Courier New"/>
                          <a:ea typeface="Times New Roman"/>
                          <a:cs typeface="Times New Roman"/>
                        </a:rPr>
                        <a:t>Plus</a:t>
                      </a:r>
                      <a:endParaRPr lang="hu-HU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7305" marR="27305" marT="6985" marB="698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115616" y="980728"/>
            <a:ext cx="6120000" cy="540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Candida] </a:t>
            </a:r>
            <a:r>
              <a:rPr kumimoji="0" lang="hu-HU" sz="100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thanolica</a:t>
            </a:r>
            <a:r>
              <a:rPr kumimoji="0" lang="hu-HU" sz="100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kumimoji="0" lang="hu-HU" sz="1000" b="1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7E-1D </a:t>
            </a:r>
            <a:r>
              <a:rPr kumimoji="0" lang="hu-HU" sz="1000" b="1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ene</a:t>
            </a:r>
            <a:r>
              <a:rPr kumimoji="0" lang="hu-HU" sz="1000" b="1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kumimoji="0" lang="hu-HU" sz="1000" b="1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or</a:t>
            </a:r>
            <a:r>
              <a:rPr kumimoji="0" lang="hu-HU" sz="1000" b="1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kumimoji="0" lang="hu-HU" sz="1000" b="1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arge</a:t>
            </a:r>
            <a:r>
              <a:rPr kumimoji="0" lang="hu-HU" sz="1000" b="1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kumimoji="0" lang="hu-HU" sz="1000" b="1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ubunit</a:t>
            </a:r>
            <a:r>
              <a:rPr kumimoji="0" lang="hu-HU" sz="1000" b="1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kumimoji="0" lang="hu-HU" sz="1000" b="1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ibosomal</a:t>
            </a:r>
            <a:r>
              <a:rPr kumimoji="0" lang="hu-HU" sz="1000" b="1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RNA, </a:t>
            </a:r>
            <a:r>
              <a:rPr kumimoji="0" lang="hu-HU" sz="1000" b="1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artial</a:t>
            </a:r>
            <a:r>
              <a:rPr kumimoji="0" lang="hu-HU" sz="1000" b="1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kumimoji="0" lang="hu-HU" sz="1000" b="1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equence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1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equence</a:t>
            </a:r>
            <a:r>
              <a:rPr kumimoji="0" lang="hu-HU" sz="1000" b="1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ID:</a:t>
            </a:r>
            <a:r>
              <a:rPr kumimoji="0" lang="hu-HU" sz="1000" b="1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alibri"/>
                <a:ea typeface="Times New Roman" pitchFamily="18" charset="0"/>
                <a:cs typeface="Courier New" pitchFamily="49" charset="0"/>
              </a:rPr>
              <a:t> </a:t>
            </a:r>
            <a:r>
              <a:rPr kumimoji="0" lang="hu-HU" sz="1000" b="1" i="0" u="none" strike="noStrike" cap="none" normalizeH="0" baseline="0" dirty="0" smtClean="0">
                <a:ln>
                  <a:noFill/>
                </a:ln>
                <a:solidFill>
                  <a:srgbClr val="4C2C92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  <a:hlinkClick r:id="rId2" tooltip="Show report for LC496579.1"/>
              </a:rPr>
              <a:t>LC496579.1</a:t>
            </a:r>
            <a:r>
              <a:rPr kumimoji="0" lang="hu-HU" sz="1000" b="1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ength:559Number of Matches:1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ange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1: 17 </a:t>
            </a: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o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559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4C2C92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  <a:hlinkClick r:id="rId3" tooltip="Aligned region spanning positions 17 to 559 on LC496579.1"/>
              </a:rPr>
              <a:t>GenBank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r>
              <a:rPr kumimoji="0" lang="hu-HU" sz="1000" b="0" i="0" u="sng" strike="noStrike" cap="none" normalizeH="0" baseline="0" dirty="0" err="1" smtClean="0">
                <a:ln>
                  <a:noFill/>
                </a:ln>
                <a:solidFill>
                  <a:srgbClr val="4C2C92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raphics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uery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1    CCTCAGTAGCGGCGAGTGAAGCGGCAAGAGCTCAGATTTGAAATCGTGTTTCGGCACGAG  60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||||||||||||||||||||||||||||||||||||||||||||||||||||||||||||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bjct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17   CCTCAGTAGCGGCGAGTGAAGCGGCAAGAGCTCAGATTTGAAATCGTGTTTCGGCACGAG  76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uery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61   TTGTAGAGTGTAGGCGGGAGTCTCTGTGGAGCGCGGTGTCCAAGTCCCTTGGAACAGGGT  120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||||||||||||||||||||||||||||||||||||||||||||||||||||||||||||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bjct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77   TTGTAGAGTGTAGGCGGGAGTCTCTGTGGAGCGCGGTGTCCAAGTCCCTTGGAACAGGGT  136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uery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121  GCCTGAGAGGGTGAGAGCCCCGTGGGGTGCTGCGCGAAGCTTTGAGGCCCTGCTGACGAG  180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||||||||||||||||||||||||||||||||||||||||||||||||||||||||||||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bjct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137  GCCTGAGAGGGTGAGAGCCCCGTGGGGTGCTGCGCGAAGCTTTGAGGCCCTGCTGACGAG  196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uery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181  TCGAGTTGTTTGGGAATGCAGCTCTAAGCGGGTGGTAAATTCCATCTAAGGCTAAATACT  240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||||||||||||||||||||||||||||||||||||||||||||||||||||||||||||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bjct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197  TCGAGTTGTTTGGGAATGCAGCTCTAAGCGGGTGGTAAATTCCATCTAAGGCTAAATACT  256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uery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241  GGCGAGAGACCGATAGCGAACAAGTACTGTGAAGGAAAGATGAAAAGCACTTTGAAAAGA  300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||||||||||||||||||||||||||||||||||||||||||||||||||||||||||||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bjct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257  GGCGAGAGACCGATAGCGAACAAGTACTGTGAAGGAAAGATGAAAAGCACTTTGAAAAGA  316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uery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301  GAGTGAAACAGCACGTGAAATTGTTGAAAGGGAAGGGTATTGGGCCCGACATGGGGAGTG  360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||||||||||||||||||||||||||||||||||||||||||||||||||||||||||||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bjct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317  GAGTGAAACAGCACGTGAAATTGTTGAAAGGGAAGGGTATTGGGCCCGACATGGGGAGTG  376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uery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361  CGCACCGCTGTCTCTTGTAGGCGGCGCTCTGGGCGCTCTCTGGGCCAGCATCGGTTCTTG  420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||||||||||||||||||||||||||||||||||||||||||||||||||||||||||||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bjct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377  CGCACCGCTGTCTCTTGTAGGCGGCGCTCTGGGCGCTCTCTGGGCCAGCATCGGTTCTTG  436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uery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421  CTGCGAGAGAAGTGGCGCCGGAAAGTGGCTCTTCGGAGTGTTATAGCCGGTGCCGGATGT  480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||||||||||||||||||||||||||||||||||||||||||||||||||||||||||||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bjct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437  CTGCGAGAGAAGTGGCGCCGGAAAGTGGCTCTTCGGAGTGTTATAGCCGGTGCCGGATGT  496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uery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481  CGCGTGCGGGGACCGAGGGCTGCGACATCTGTCTCGGATGCTGGCACAACGGCGCAATAC  540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||||||||||||||||||||||||||||||||||||||||||||||||||||||||||||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bjct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497  CGCGTGCGGGGACCGAGGGCTGCGACATCTGTCTCGGATGCTGGCACAACGGCGCAATAC  556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uery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541  CGC  543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|||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hu-HU" sz="1000" b="0" i="0" u="none" strike="noStrike" cap="none" normalizeH="0" baseline="0" dirty="0" err="1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bjct</a:t>
            </a:r>
            <a:r>
              <a:rPr kumimoji="0" lang="hu-HU" sz="1000" b="0" i="0" u="none" strike="noStrike" cap="none" normalizeH="0" baseline="0" dirty="0" smtClean="0">
                <a:ln>
                  <a:noFill/>
                </a:ln>
                <a:solidFill>
                  <a:srgbClr val="21212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557  CGC  559</a:t>
            </a:r>
            <a:endParaRPr kumimoji="0" lang="hu-HU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kumimoji="0" lang="hu-H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36</Words>
  <Application>Microsoft Office PowerPoint</Application>
  <PresentationFormat>Diavetítés a képernyőre (4:3 oldalarány)</PresentationFormat>
  <Paragraphs>44</Paragraphs>
  <Slides>1</Slides>
  <Notes>0</Notes>
  <HiddenSlides>0</HiddenSlides>
  <MMClips>0</MMClips>
  <ScaleCrop>false</ScaleCrop>
  <HeadingPairs>
    <vt:vector size="4" baseType="variant"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2" baseType="lpstr">
      <vt:lpstr>Office-téma</vt:lpstr>
      <vt:lpstr>1. dia</vt:lpstr>
    </vt:vector>
  </TitlesOfParts>
  <Company>WXPE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. dia</dc:title>
  <dc:creator>Genetika</dc:creator>
  <cp:lastModifiedBy>Genetika</cp:lastModifiedBy>
  <cp:revision>2</cp:revision>
  <dcterms:created xsi:type="dcterms:W3CDTF">2020-03-14T18:16:27Z</dcterms:created>
  <dcterms:modified xsi:type="dcterms:W3CDTF">2020-07-09T08:13:38Z</dcterms:modified>
</cp:coreProperties>
</file>